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1824" y="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4/02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2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2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2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2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2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2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2/2021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2/2021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2/2021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2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2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4/02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869721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von Scholten et al (2021) Diabetologia DOI 10.1007/s00125-021-05398-3 </a:t>
            </a:r>
          </a:p>
          <a:p>
            <a:r>
              <a:rPr lang="en-GB" sz="1200" dirty="0"/>
              <a:t>©The Authors 2021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53752" y="116632"/>
            <a:ext cx="903649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Hallmarks of the evolving profile of the individual with type 1 diabetes, and current and future options for the prevention of this disease and for the management of its associated complication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4A8FD7B-295A-4EC0-BEAE-977A8321BAC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57657" y="1219853"/>
            <a:ext cx="4628685" cy="48014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7</TotalTime>
  <Words>74</Words>
  <Application>Microsoft Office PowerPoint</Application>
  <PresentationFormat>On-screen Show (4:3)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ose Ruffino</cp:lastModifiedBy>
  <cp:revision>37</cp:revision>
  <dcterms:created xsi:type="dcterms:W3CDTF">2016-06-15T12:53:43Z</dcterms:created>
  <dcterms:modified xsi:type="dcterms:W3CDTF">2021-02-04T11:30:27Z</dcterms:modified>
</cp:coreProperties>
</file>